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C0D53F-E425-48AF-A897-8151C22312F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ru-RU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Номер слайда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1EAEE6E-FA7A-423B-92B9-486B2E4745B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BF2F6-0869-4D55-947E-D093AB2E87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1A1E6-C6CA-486D-B562-1475AC0CB4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D4F6A-790C-4EE6-B85D-385328010D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D80A1-7389-4008-B537-FA9E62D08E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94EC5-8EC3-4DD5-A295-69BCE40B12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8A85DB-AC64-48B5-858E-830310C5AE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626751-E58B-45C1-814D-18DABCA0E8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2568E-3884-4217-845A-DFDA43907B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536E2-F5E3-482F-9122-A0124DF2EE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C28A0-42A8-48EF-81C3-746C43DE98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43F66-AAEE-496C-8FAF-9D7D9139B1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E18AD-2487-444B-AD6D-8D1A3B4660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1E5BDC-D0B2-4423-808D-18F09A06AC6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539640" y="3090960"/>
          <a:ext cx="2476440" cy="2352600"/>
        </p:xfrm>
        <a:graphic>
          <a:graphicData uri="http://schemas.openxmlformats.org/drawingml/2006/table">
            <a:tbl>
              <a:tblPr/>
              <a:tblGrid>
                <a:gridCol w="825480"/>
                <a:gridCol w="825480"/>
                <a:gridCol w="825480"/>
              </a:tblGrid>
              <a:tr h="16884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F_NA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RIX_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-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2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LK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7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40E-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2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BP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8E-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884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2F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89E-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2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LK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8E-2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2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IZF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1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7E-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40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F1A::AR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25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27E-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2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nt::A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0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6E-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2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FAP2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5E-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884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Y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6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92E-0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2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34E-0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920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pl-PL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c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1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5E-0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84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lf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3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0E-0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3519360" y="3090960"/>
          <a:ext cx="2476800" cy="2352600"/>
        </p:xfrm>
        <a:graphic>
          <a:graphicData uri="http://schemas.openxmlformats.org/drawingml/2006/table">
            <a:tbl>
              <a:tblPr/>
              <a:tblGrid>
                <a:gridCol w="825480"/>
                <a:gridCol w="825480"/>
                <a:gridCol w="825840"/>
              </a:tblGrid>
              <a:tr h="18072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F_NA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TRIX_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-VALU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lf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3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74E-3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P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7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86E-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072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FAP2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93E-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fx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14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84E-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G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16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75E-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072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KB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1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85E-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r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1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78E-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M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15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57E-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072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x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8E-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fi-FI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F-kappa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6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9E-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ZF1_5-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4E-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ZF1_1-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005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7E-0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0" name="TextBox 1"/>
          <p:cNvSpPr/>
          <p:nvPr/>
        </p:nvSpPr>
        <p:spPr>
          <a:xfrm>
            <a:off x="389160" y="2649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4"/>
          <p:cNvSpPr/>
          <p:nvPr/>
        </p:nvSpPr>
        <p:spPr>
          <a:xfrm>
            <a:off x="3330720" y="26431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6"/>
          <p:cNvSpPr/>
          <p:nvPr/>
        </p:nvSpPr>
        <p:spPr>
          <a:xfrm>
            <a:off x="259920" y="8661240"/>
            <a:ext cx="26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artynova et al. Supplementary 4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87680" y="2678040"/>
            <a:ext cx="2087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Mutp53-activat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708720" y="2674800"/>
            <a:ext cx="216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Mutp53-repressed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55760" y="1866960"/>
            <a:ext cx="5789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600" spc="-1" strike="noStrike">
                <a:solidFill>
                  <a:srgbClr val="000000"/>
                </a:solidFill>
                <a:latin typeface="Arial"/>
              </a:rPr>
              <a:t>Expression analysis: TFBS analysis of mutp53 regulated promoter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6T13:29:45Z</dcterms:created>
  <dc:creator>Roberto Matovani</dc:creator>
  <dc:description/>
  <dc:language>en-US</dc:language>
  <cp:lastModifiedBy>Roberto Matovani</cp:lastModifiedBy>
  <dcterms:modified xsi:type="dcterms:W3CDTF">2011-12-27T14:34:17Z</dcterms:modified>
  <cp:revision>2</cp:revision>
  <dc:subject/>
  <dc:title>Slide 1</dc:title>
</cp:coreProperties>
</file>